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0CD72D9-60A5-1D47-AEC6-5ABF9F74457E}" v="12" dt="2025-09-09T12:58:35.69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20"/>
    <p:restoredTop sz="94762"/>
  </p:normalViewPr>
  <p:slideViewPr>
    <p:cSldViewPr snapToGrid="0">
      <p:cViewPr varScale="1">
        <p:scale>
          <a:sx n="121" d="100"/>
          <a:sy n="121" d="100"/>
        </p:scale>
        <p:origin x="32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row, Allister" userId="e36c9bbd-3fd4-41c8-a297-2d5be464d6d8" providerId="ADAL" clId="{390F478F-C19D-5DE7-BF51-12FDE8BB4B37}"/>
    <pc:docChg chg="undo custSel modSld">
      <pc:chgData name="Crow, Allister" userId="e36c9bbd-3fd4-41c8-a297-2d5be464d6d8" providerId="ADAL" clId="{390F478F-C19D-5DE7-BF51-12FDE8BB4B37}" dt="2025-09-18T16:29:46.347" v="423" actId="20577"/>
      <pc:docMkLst>
        <pc:docMk/>
      </pc:docMkLst>
      <pc:sldChg chg="addSp delSp modSp mod">
        <pc:chgData name="Crow, Allister" userId="e36c9bbd-3fd4-41c8-a297-2d5be464d6d8" providerId="ADAL" clId="{390F478F-C19D-5DE7-BF51-12FDE8BB4B37}" dt="2025-09-18T16:29:46.347" v="423" actId="20577"/>
        <pc:sldMkLst>
          <pc:docMk/>
          <pc:sldMk cId="1952130909" sldId="256"/>
        </pc:sldMkLst>
        <pc:spChg chg="mod">
          <ac:chgData name="Crow, Allister" userId="e36c9bbd-3fd4-41c8-a297-2d5be464d6d8" providerId="ADAL" clId="{390F478F-C19D-5DE7-BF51-12FDE8BB4B37}" dt="2025-09-09T12:59:41.927" v="415" actId="20577"/>
          <ac:spMkLst>
            <pc:docMk/>
            <pc:sldMk cId="1952130909" sldId="256"/>
            <ac:spMk id="7" creationId="{33DC74B4-B481-5131-172C-7EE4F74CA16D}"/>
          </ac:spMkLst>
        </pc:spChg>
        <pc:spChg chg="mod">
          <ac:chgData name="Crow, Allister" userId="e36c9bbd-3fd4-41c8-a297-2d5be464d6d8" providerId="ADAL" clId="{390F478F-C19D-5DE7-BF51-12FDE8BB4B37}" dt="2025-09-09T12:57:33.716" v="195" actId="1076"/>
          <ac:spMkLst>
            <pc:docMk/>
            <pc:sldMk cId="1952130909" sldId="256"/>
            <ac:spMk id="8" creationId="{4758C1F3-947D-F4F6-81DC-3100C0AA9D29}"/>
          </ac:spMkLst>
        </pc:spChg>
        <pc:spChg chg="mod">
          <ac:chgData name="Crow, Allister" userId="e36c9bbd-3fd4-41c8-a297-2d5be464d6d8" providerId="ADAL" clId="{390F478F-C19D-5DE7-BF51-12FDE8BB4B37}" dt="2025-09-09T12:59:07.023" v="342" actId="1036"/>
          <ac:spMkLst>
            <pc:docMk/>
            <pc:sldMk cId="1952130909" sldId="256"/>
            <ac:spMk id="10" creationId="{2E1245E0-FFDC-EF71-7275-954BFC0402FE}"/>
          </ac:spMkLst>
        </pc:spChg>
        <pc:spChg chg="mod">
          <ac:chgData name="Crow, Allister" userId="e36c9bbd-3fd4-41c8-a297-2d5be464d6d8" providerId="ADAL" clId="{390F478F-C19D-5DE7-BF51-12FDE8BB4B37}" dt="2025-09-18T16:29:46.347" v="423" actId="20577"/>
          <ac:spMkLst>
            <pc:docMk/>
            <pc:sldMk cId="1952130909" sldId="256"/>
            <ac:spMk id="13" creationId="{FFD9B2C0-7599-02BE-743F-F078AF915E83}"/>
          </ac:spMkLst>
        </pc:spChg>
        <pc:spChg chg="add mod">
          <ac:chgData name="Crow, Allister" userId="e36c9bbd-3fd4-41c8-a297-2d5be464d6d8" providerId="ADAL" clId="{390F478F-C19D-5DE7-BF51-12FDE8BB4B37}" dt="2025-09-09T12:59:20.184" v="402" actId="1036"/>
          <ac:spMkLst>
            <pc:docMk/>
            <pc:sldMk cId="1952130909" sldId="256"/>
            <ac:spMk id="19" creationId="{D35E3B78-39D9-BE02-1971-5C5D8798CE48}"/>
          </ac:spMkLst>
        </pc:spChg>
        <pc:picChg chg="add mod">
          <ac:chgData name="Crow, Allister" userId="e36c9bbd-3fd4-41c8-a297-2d5be464d6d8" providerId="ADAL" clId="{390F478F-C19D-5DE7-BF51-12FDE8BB4B37}" dt="2025-09-09T12:57:49.094" v="211" actId="1036"/>
          <ac:picMkLst>
            <pc:docMk/>
            <pc:sldMk cId="1952130909" sldId="256"/>
            <ac:picMk id="3" creationId="{09517A07-EAEC-A750-DF5C-4AD58F2383E5}"/>
          </ac:picMkLst>
        </pc:picChg>
        <pc:picChg chg="add mod">
          <ac:chgData name="Crow, Allister" userId="e36c9bbd-3fd4-41c8-a297-2d5be464d6d8" providerId="ADAL" clId="{390F478F-C19D-5DE7-BF51-12FDE8BB4B37}" dt="2025-09-09T12:59:07.023" v="342" actId="1036"/>
          <ac:picMkLst>
            <pc:docMk/>
            <pc:sldMk cId="1952130909" sldId="256"/>
            <ac:picMk id="5" creationId="{BA5121CB-7CA4-90B6-9203-8027ABB1321D}"/>
          </ac:picMkLst>
        </pc:picChg>
        <pc:picChg chg="add mod">
          <ac:chgData name="Crow, Allister" userId="e36c9bbd-3fd4-41c8-a297-2d5be464d6d8" providerId="ADAL" clId="{390F478F-C19D-5DE7-BF51-12FDE8BB4B37}" dt="2025-09-09T12:59:07.023" v="342" actId="1036"/>
          <ac:picMkLst>
            <pc:docMk/>
            <pc:sldMk cId="1952130909" sldId="256"/>
            <ac:picMk id="11" creationId="{1DC8EBF4-F921-7E6F-D0D7-4AF8CAEE1171}"/>
          </ac:picMkLst>
        </pc:picChg>
        <pc:picChg chg="add mod modCrop">
          <ac:chgData name="Crow, Allister" userId="e36c9bbd-3fd4-41c8-a297-2d5be464d6d8" providerId="ADAL" clId="{390F478F-C19D-5DE7-BF51-12FDE8BB4B37}" dt="2025-09-09T12:59:20.184" v="402" actId="1036"/>
          <ac:picMkLst>
            <pc:docMk/>
            <pc:sldMk cId="1952130909" sldId="256"/>
            <ac:picMk id="16" creationId="{421FA305-69EE-7772-84BA-DD7F35726433}"/>
          </ac:picMkLst>
        </pc:picChg>
        <pc:picChg chg="add mod">
          <ac:chgData name="Crow, Allister" userId="e36c9bbd-3fd4-41c8-a297-2d5be464d6d8" providerId="ADAL" clId="{390F478F-C19D-5DE7-BF51-12FDE8BB4B37}" dt="2025-09-09T12:59:20.184" v="402" actId="1036"/>
          <ac:picMkLst>
            <pc:docMk/>
            <pc:sldMk cId="1952130909" sldId="256"/>
            <ac:picMk id="18" creationId="{0CA23991-D24F-0034-598E-76CE3E1D74EE}"/>
          </ac:picMkLst>
        </pc:picChg>
        <pc:cxnChg chg="add mod">
          <ac:chgData name="Crow, Allister" userId="e36c9bbd-3fd4-41c8-a297-2d5be464d6d8" providerId="ADAL" clId="{390F478F-C19D-5DE7-BF51-12FDE8BB4B37}" dt="2025-09-09T12:59:07.023" v="342" actId="1036"/>
          <ac:cxnSpMkLst>
            <pc:docMk/>
            <pc:sldMk cId="1952130909" sldId="256"/>
            <ac:cxnSpMk id="14" creationId="{1AA8689D-48CA-286D-B939-910C6E1A124D}"/>
          </ac:cxnSpMkLst>
        </pc:cxnChg>
        <pc:cxnChg chg="mod">
          <ac:chgData name="Crow, Allister" userId="e36c9bbd-3fd4-41c8-a297-2d5be464d6d8" providerId="ADAL" clId="{390F478F-C19D-5DE7-BF51-12FDE8BB4B37}" dt="2025-09-09T12:59:26.342" v="403" actId="14100"/>
          <ac:cxnSpMkLst>
            <pc:docMk/>
            <pc:sldMk cId="1952130909" sldId="256"/>
            <ac:cxnSpMk id="15" creationId="{C2E25E9A-BA73-80B0-318D-46C229764CE6}"/>
          </ac:cxnSpMkLst>
        </pc:cxnChg>
        <pc:cxnChg chg="add mod">
          <ac:chgData name="Crow, Allister" userId="e36c9bbd-3fd4-41c8-a297-2d5be464d6d8" providerId="ADAL" clId="{390F478F-C19D-5DE7-BF51-12FDE8BB4B37}" dt="2025-09-09T12:59:20.184" v="402" actId="1036"/>
          <ac:cxnSpMkLst>
            <pc:docMk/>
            <pc:sldMk cId="1952130909" sldId="256"/>
            <ac:cxnSpMk id="17" creationId="{642EC337-C70B-AB3E-11ED-EF7AF8028549}"/>
          </ac:cxnSpMkLst>
        </pc:cxnChg>
        <pc:cxnChg chg="add mod">
          <ac:chgData name="Crow, Allister" userId="e36c9bbd-3fd4-41c8-a297-2d5be464d6d8" providerId="ADAL" clId="{390F478F-C19D-5DE7-BF51-12FDE8BB4B37}" dt="2025-09-09T12:58:45.635" v="234" actId="14100"/>
          <ac:cxnSpMkLst>
            <pc:docMk/>
            <pc:sldMk cId="1952130909" sldId="256"/>
            <ac:cxnSpMk id="21" creationId="{3ACB7035-1650-B1FB-E8EA-17F1EF8B9E2F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41F7B2-68AF-9768-ED29-A0CAB14A1F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FDF996C-340E-C0CB-79F8-15DBDBECE0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A78994-CE89-C211-4BD5-C764ABC67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2F13FF-7D9A-B907-2845-167C42BB4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697D50-1773-68A6-D42B-F4201D43D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8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146443-69BE-9271-229D-AD4CD35DDB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E69F6A-C5F4-2FAF-93AE-394D8AAB88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60307E-B88A-56FC-8812-F247A4F7F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7AA795-7AB8-22F5-9ADF-1959806AA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664D1C-B861-9E58-70F9-103B18341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81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02E03E-4545-F2B0-195C-496BD06D9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9E0E13-A0E7-D2B7-B6F3-D8E5983AA8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08FE20-2ECA-FAF3-07CC-730875E35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81C699-A51C-49EE-A76C-6FCED998D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1526AE-1111-9FC7-9FA3-D9AA10C6C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429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22DB7-DB06-7B9B-BC5C-7B5C09184D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251176-91C5-DF23-290F-DFBB77349F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8F6DB8-9C12-707D-81B5-9F5682EC9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A1EE38-A36E-1FAF-4F2A-7D17DAA81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FDFA66-69DF-7665-09AC-90B30AE70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29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EE5D16-67D2-D5FB-70FC-6B0A04642B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54744C-9E4E-B729-6EE3-62D0904DED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C8177F-D19A-C05B-02EC-0F356C83D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14DA6A-C464-02A7-C84C-9F1DDBEB7B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802114-8660-0F24-D289-ECF80F1B5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05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D6C7B7-E975-7CB9-880F-A93FD20A0E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EF9DBC-92CC-191A-4702-157A9E166C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A3C326-37E2-2A00-BE7B-D6266F46B4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00F608-C3A8-A3CD-AE72-CB9768CEFC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AA245C-8495-D9F9-357D-CA32D175C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6C3D3C-FA7F-1CAD-7CC1-EC01642C1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644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485B15-0495-28AF-5AF7-5D1F73A83E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892864-5DF4-DD26-C8EC-6091BD2F94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4D9680-C57A-3B70-813E-FAD5101559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23A664-5D91-19F1-8C57-CBD8C90F6A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529565E-939B-857C-778C-9036549D4E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67D10F4-CDC3-2A4E-37F2-8BCE4C92B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C2943D-A7E0-264D-829A-C22CC000E7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974F3BB-8F60-C02A-B5E3-1860A4421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362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B3DBEE-810F-DA1C-785C-F9AC441063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AC9D2D-0678-8F0D-8B74-F56E21998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CBB35A3-9EA6-A32B-50A2-438C668D3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064721C-7A2A-FD80-7F73-B9F38028C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890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0BFC37-8E89-8961-ADD8-4FC9A7606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D4F803-B016-F634-3F57-FB517BF6A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C43EF6-9CCF-B99C-D660-5192CAF3C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201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544D79-41A0-B7A2-8A65-66DE828051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4F0AA0-21AB-AC12-AFB1-CBFB89CF0C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2F1581-BA12-9745-2449-F11C953364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8468B2-B2E7-7C73-6710-A3A98629F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8F3AD3-2CC0-AFB2-0DB5-72811E1CE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3A4F46-2E3E-E121-9AC8-84459EFFD6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496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E0FF89-1228-B69C-0443-557AE577C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795C11-0977-5F35-97AE-55B80A8F7E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2A2539-4ABE-A697-0603-205D75A115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EA0D8F-353E-7E13-55D2-90B020F0B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79FA20-8A4E-7165-92C5-32D7DAA47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A01E92-17DA-9186-58A6-80AEFA817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632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3BAB1CD-54EE-F11E-E8EE-1B0387EF84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C8C6A3-A680-2E07-76D9-345B1C4CAA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9BC633-14F3-51FC-530A-D2B07A4D5F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197B20-DF34-7743-B73E-08119F9BBFF6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CB8E85-916B-0BD6-667A-9DCD49A7E4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42BE75-129C-05BB-5DBC-41E3D6E8DB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6EDD09-A64E-9741-8589-797CBFD26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179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close-up of a dna test&#10;&#10;AI-generated content may be incorrect.">
            <a:extLst>
              <a:ext uri="{FF2B5EF4-FFF2-40B4-BE49-F238E27FC236}">
                <a16:creationId xmlns:a16="http://schemas.microsoft.com/office/drawing/2014/main" id="{1DC8EBF4-F921-7E6F-D0D7-4AF8CAEE11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27070" y="4207968"/>
            <a:ext cx="3225800" cy="25908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3DC74B4-B481-5131-172C-7EE4F74CA16D}"/>
              </a:ext>
            </a:extLst>
          </p:cNvPr>
          <p:cNvSpPr txBox="1"/>
          <p:nvPr/>
        </p:nvSpPr>
        <p:spPr>
          <a:xfrm>
            <a:off x="373631" y="137886"/>
            <a:ext cx="269894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1D uncropped gels</a:t>
            </a:r>
          </a:p>
          <a:p>
            <a:r>
              <a:rPr lang="en-US" dirty="0"/>
              <a:t>Top YbbAP-TesA WT</a:t>
            </a:r>
          </a:p>
          <a:p>
            <a:r>
              <a:rPr lang="en-US" dirty="0"/>
              <a:t>Bottom YbbAP-TesA S36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758C1F3-947D-F4F6-81DC-3100C0AA9D29}"/>
              </a:ext>
            </a:extLst>
          </p:cNvPr>
          <p:cNvSpPr txBox="1"/>
          <p:nvPr/>
        </p:nvSpPr>
        <p:spPr>
          <a:xfrm>
            <a:off x="5502788" y="267308"/>
            <a:ext cx="259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pproximate crops used</a:t>
            </a:r>
          </a:p>
        </p:txBody>
      </p:sp>
      <p:sp>
        <p:nvSpPr>
          <p:cNvPr id="10" name="Rounded Rectangle 9">
            <a:extLst>
              <a:ext uri="{FF2B5EF4-FFF2-40B4-BE49-F238E27FC236}">
                <a16:creationId xmlns:a16="http://schemas.microsoft.com/office/drawing/2014/main" id="{2E1245E0-FFDC-EF71-7275-954BFC0402FE}"/>
              </a:ext>
            </a:extLst>
          </p:cNvPr>
          <p:cNvSpPr/>
          <p:nvPr/>
        </p:nvSpPr>
        <p:spPr>
          <a:xfrm>
            <a:off x="6496242" y="4667913"/>
            <a:ext cx="642299" cy="1834235"/>
          </a:xfrm>
          <a:prstGeom prst="round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FD9B2C0-7599-02BE-743F-F078AF915E83}"/>
              </a:ext>
            </a:extLst>
          </p:cNvPr>
          <p:cNvSpPr txBox="1"/>
          <p:nvPr/>
        </p:nvSpPr>
        <p:spPr>
          <a:xfrm>
            <a:off x="9754671" y="1708910"/>
            <a:ext cx="168494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As </a:t>
            </a:r>
            <a:r>
              <a:rPr lang="en-US" dirty="0"/>
              <a:t>gels appear</a:t>
            </a:r>
          </a:p>
          <a:p>
            <a:pPr algn="ctr"/>
            <a:r>
              <a:rPr lang="en-US" dirty="0"/>
              <a:t> in final figure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2E25E9A-BA73-80B0-318D-46C229764CE6}"/>
              </a:ext>
            </a:extLst>
          </p:cNvPr>
          <p:cNvCxnSpPr>
            <a:cxnSpLocks/>
          </p:cNvCxnSpPr>
          <p:nvPr/>
        </p:nvCxnSpPr>
        <p:spPr>
          <a:xfrm>
            <a:off x="8708778" y="2627067"/>
            <a:ext cx="552138" cy="35792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A close-up of several dna samples&#10;&#10;AI-generated content may be incorrect.">
            <a:extLst>
              <a:ext uri="{FF2B5EF4-FFF2-40B4-BE49-F238E27FC236}">
                <a16:creationId xmlns:a16="http://schemas.microsoft.com/office/drawing/2014/main" id="{09517A07-EAEC-A750-DF5C-4AD58F2383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42577" y="2355241"/>
            <a:ext cx="2490615" cy="1896110"/>
          </a:xfrm>
          <a:prstGeom prst="rect">
            <a:avLst/>
          </a:prstGeom>
        </p:spPr>
      </p:pic>
      <p:pic>
        <p:nvPicPr>
          <p:cNvPr id="5" name="Picture 4" descr="A close-up of a dna test&#10;&#10;AI-generated content may be incorrect.">
            <a:extLst>
              <a:ext uri="{FF2B5EF4-FFF2-40B4-BE49-F238E27FC236}">
                <a16:creationId xmlns:a16="http://schemas.microsoft.com/office/drawing/2014/main" id="{BA5121CB-7CA4-90B6-9203-8027ABB132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038" y="4195616"/>
            <a:ext cx="3225800" cy="2590800"/>
          </a:xfrm>
          <a:prstGeom prst="rect">
            <a:avLst/>
          </a:prstGeom>
        </p:spPr>
      </p:pic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1AA8689D-48CA-286D-B939-910C6E1A124D}"/>
              </a:ext>
            </a:extLst>
          </p:cNvPr>
          <p:cNvCxnSpPr>
            <a:cxnSpLocks/>
          </p:cNvCxnSpPr>
          <p:nvPr/>
        </p:nvCxnSpPr>
        <p:spPr>
          <a:xfrm>
            <a:off x="3485158" y="5442723"/>
            <a:ext cx="926385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6" name="Picture 15" descr="A close-up of a dna test&#10;&#10;AI-generated content may be incorrect.">
            <a:extLst>
              <a:ext uri="{FF2B5EF4-FFF2-40B4-BE49-F238E27FC236}">
                <a16:creationId xmlns:a16="http://schemas.microsoft.com/office/drawing/2014/main" id="{421FA305-69EE-7772-84BA-DD7F3572643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-2303" t="-1491" r="-3715" b="-3040"/>
          <a:stretch>
            <a:fillRect/>
          </a:stretch>
        </p:blipFill>
        <p:spPr>
          <a:xfrm>
            <a:off x="138068" y="1205615"/>
            <a:ext cx="3774365" cy="2971853"/>
          </a:xfrm>
          <a:prstGeom prst="rect">
            <a:avLst/>
          </a:prstGeom>
          <a:ln>
            <a:noFill/>
          </a:ln>
        </p:spPr>
      </p:pic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42EC337-C70B-AB3E-11ED-EF7AF8028549}"/>
              </a:ext>
            </a:extLst>
          </p:cNvPr>
          <p:cNvCxnSpPr>
            <a:cxnSpLocks/>
          </p:cNvCxnSpPr>
          <p:nvPr/>
        </p:nvCxnSpPr>
        <p:spPr>
          <a:xfrm>
            <a:off x="3796597" y="2627067"/>
            <a:ext cx="926385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8" name="Picture 17" descr="A close-up of a dna test&#10;&#10;AI-generated content may be incorrect.">
            <a:extLst>
              <a:ext uri="{FF2B5EF4-FFF2-40B4-BE49-F238E27FC236}">
                <a16:creationId xmlns:a16="http://schemas.microsoft.com/office/drawing/2014/main" id="{0CA23991-D24F-0034-598E-76CE3E1D74E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-2303" t="-1491" r="-3715" b="-3040"/>
          <a:stretch>
            <a:fillRect/>
          </a:stretch>
        </p:blipFill>
        <p:spPr>
          <a:xfrm>
            <a:off x="4767837" y="1205614"/>
            <a:ext cx="3774365" cy="2971853"/>
          </a:xfrm>
          <a:prstGeom prst="rect">
            <a:avLst/>
          </a:prstGeom>
          <a:ln>
            <a:noFill/>
          </a:ln>
        </p:spPr>
      </p:pic>
      <p:sp>
        <p:nvSpPr>
          <p:cNvPr id="19" name="Rounded Rectangle 18">
            <a:extLst>
              <a:ext uri="{FF2B5EF4-FFF2-40B4-BE49-F238E27FC236}">
                <a16:creationId xmlns:a16="http://schemas.microsoft.com/office/drawing/2014/main" id="{D35E3B78-39D9-BE02-1971-5C5D8798CE48}"/>
              </a:ext>
            </a:extLst>
          </p:cNvPr>
          <p:cNvSpPr/>
          <p:nvPr/>
        </p:nvSpPr>
        <p:spPr>
          <a:xfrm>
            <a:off x="5959590" y="1701274"/>
            <a:ext cx="609600" cy="1834235"/>
          </a:xfrm>
          <a:prstGeom prst="round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3ACB7035-1650-B1FB-E8EA-17F1EF8B9E2F}"/>
              </a:ext>
            </a:extLst>
          </p:cNvPr>
          <p:cNvCxnSpPr>
            <a:cxnSpLocks/>
          </p:cNvCxnSpPr>
          <p:nvPr/>
        </p:nvCxnSpPr>
        <p:spPr>
          <a:xfrm flipV="1">
            <a:off x="8708778" y="4324562"/>
            <a:ext cx="2144101" cy="91711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52130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20</Words>
  <Application>Microsoft Macintosh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row, Allister</dc:creator>
  <cp:lastModifiedBy>Crow, Allister</cp:lastModifiedBy>
  <cp:revision>1</cp:revision>
  <dcterms:created xsi:type="dcterms:W3CDTF">2025-09-09T10:53:20Z</dcterms:created>
  <dcterms:modified xsi:type="dcterms:W3CDTF">2025-09-18T16:29:47Z</dcterms:modified>
</cp:coreProperties>
</file>